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55FBD-77AB-415E-AF3E-6A6481A2DA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CF9F30-42E1-4A96-8DD3-9A2225418F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757E6-5A5E-4C53-AE81-5D9218A998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BC04C-83F6-4C18-A8E6-4E9DCA4AB9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F00EA6-EA58-4D41-9E42-F8AC4699ED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CAA2C-A476-403A-B8DD-DD9798181A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0129B-DCC2-4A97-8003-32B866D0F4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90CDB-8CEF-47AD-AFFE-08B778070E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3ECB7-5D70-4C76-952F-33D14F05AE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0EE0E-284B-47E3-8F48-9AEE49253B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733CF-0B72-4B4A-8FD6-0A274786F3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6622B-3419-4488-AEDD-5976D202C0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3760AF-F73D-4933-A853-A4949F68B98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slideLayout" Target="../slideLayouts/slideLayout1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45720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895480" y="45720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228600" y="762120"/>
            <a:ext cx="2514600" cy="157140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2"/>
          <a:stretch/>
        </p:blipFill>
        <p:spPr>
          <a:xfrm>
            <a:off x="2666880" y="838080"/>
            <a:ext cx="3886200" cy="342900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"/>
          <p:cNvSpPr/>
          <p:nvPr/>
        </p:nvSpPr>
        <p:spPr>
          <a:xfrm>
            <a:off x="0" y="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311040" y="533520"/>
            <a:ext cx="6546960" cy="800100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3352680" y="87631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0" y="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200400" y="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0" y="44956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200400" y="44956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152280" y="457200"/>
            <a:ext cx="3886200" cy="299088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3124080" y="380880"/>
            <a:ext cx="3486240" cy="339264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3"/>
          <a:stretch/>
        </p:blipFill>
        <p:spPr>
          <a:xfrm>
            <a:off x="0" y="4952880"/>
            <a:ext cx="3733920" cy="229104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4"/>
          <a:stretch/>
        </p:blipFill>
        <p:spPr>
          <a:xfrm>
            <a:off x="3276720" y="4952880"/>
            <a:ext cx="3581280" cy="246708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>
            <a:off x="3581280" y="8534520"/>
            <a:ext cx="327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"/>
          <p:cNvSpPr/>
          <p:nvPr/>
        </p:nvSpPr>
        <p:spPr>
          <a:xfrm>
            <a:off x="0" y="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200400" y="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0" y="35812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276720" y="358128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0" y="662940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124080" y="662940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380880" y="457200"/>
            <a:ext cx="2819520" cy="1279440"/>
          </a:xfrm>
          <a:prstGeom prst="rect">
            <a:avLst/>
          </a:prstGeom>
          <a:ln w="0">
            <a:noFill/>
          </a:ln>
        </p:spPr>
      </p:pic>
      <p:pic>
        <p:nvPicPr>
          <p:cNvPr id="65" name="" descr=""/>
          <p:cNvPicPr/>
          <p:nvPr/>
        </p:nvPicPr>
        <p:blipFill>
          <a:blip r:embed="rId2"/>
          <a:stretch/>
        </p:blipFill>
        <p:spPr>
          <a:xfrm>
            <a:off x="3124080" y="609480"/>
            <a:ext cx="3733920" cy="276876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3"/>
          <a:stretch/>
        </p:blipFill>
        <p:spPr>
          <a:xfrm>
            <a:off x="0" y="4191120"/>
            <a:ext cx="4114800" cy="239688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4"/>
          <a:stretch/>
        </p:blipFill>
        <p:spPr>
          <a:xfrm>
            <a:off x="3581280" y="4191120"/>
            <a:ext cx="3276720" cy="173808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5"/>
          <a:stretch/>
        </p:blipFill>
        <p:spPr>
          <a:xfrm>
            <a:off x="228600" y="6934320"/>
            <a:ext cx="2819520" cy="163656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6"/>
          <a:stretch/>
        </p:blipFill>
        <p:spPr>
          <a:xfrm>
            <a:off x="3505320" y="7010280"/>
            <a:ext cx="2819160" cy="1571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8T23:53:00Z</dcterms:created>
  <dc:creator>Ming Yi</dc:creator>
  <dc:description/>
  <dc:language>en-US</dc:language>
  <cp:lastModifiedBy>Ming Yi</cp:lastModifiedBy>
  <dcterms:modified xsi:type="dcterms:W3CDTF">2012-02-09T00:17:14Z</dcterms:modified>
  <cp:revision>2</cp:revision>
  <dc:subject/>
  <dc:title>Slide 1</dc:title>
</cp:coreProperties>
</file>